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32482C-5E9A-43F8-8A30-82E6DFF6D122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8FDA71-3C18-4A85-9CE0-B03C25C6D1D5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93097-081C-4BEC-98A0-87E539D58B9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1781DE-6C10-4EDD-8F66-88BE037F96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B9C17-24C5-4B32-8990-071E738F45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44BAA-671A-498E-BCCC-FFA771A6DC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3A8C6-86B1-4763-82ED-B527E5C0EF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DC3B8-91FC-4DCE-AD09-6DC4B3EE3C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7EF67-A40B-4A1D-85B7-9421873CA6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B05497-216B-4357-A2D6-8B95FE8875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B482D-7D6E-4578-9218-192498F14A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A7A58D-D923-4FA2-918E-A7352B2CCA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B1CBA-B5EA-4F05-93AC-F81E47D83C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1EE1B-2116-4CBD-BB61-1A48D8775F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45C9D7-E200-48E6-9C42-725D2B40AF78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正方形/長方形 7"/>
          <p:cNvSpPr/>
          <p:nvPr/>
        </p:nvSpPr>
        <p:spPr>
          <a:xfrm>
            <a:off x="500040" y="5086440"/>
            <a:ext cx="80010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CR amplicon: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hr10:89,612,858-89,613,08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orward primer sequence: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aggaagagagTTTAGTGTAGTTGTTTGG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everse primer sequence: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cagtaatacgactcactatagggagaaggctCAAACTCRAATCAATAACA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>
            <a:off x="1071720" y="1328760"/>
            <a:ext cx="6929280" cy="33861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2"/>
          <a:stretch/>
        </p:blipFill>
        <p:spPr>
          <a:xfrm>
            <a:off x="1219320" y="571680"/>
            <a:ext cx="6781680" cy="218880"/>
          </a:xfrm>
          <a:prstGeom prst="rect">
            <a:avLst/>
          </a:prstGeom>
          <a:ln w="0">
            <a:noFill/>
          </a:ln>
        </p:spPr>
      </p:pic>
      <p:sp>
        <p:nvSpPr>
          <p:cNvPr id="51" name="二等辺三角形 10"/>
          <p:cNvSpPr/>
          <p:nvPr/>
        </p:nvSpPr>
        <p:spPr>
          <a:xfrm>
            <a:off x="2093760" y="808200"/>
            <a:ext cx="5857920" cy="428400"/>
          </a:xfrm>
          <a:prstGeom prst="triangle">
            <a:avLst>
              <a:gd name="adj" fmla="val 66231"/>
            </a:avLst>
          </a:prstGeom>
          <a:solidFill>
            <a:srgbClr val="f2f2f2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直線矢印コネクタ 13"/>
          <p:cNvCxnSpPr/>
          <p:nvPr/>
        </p:nvCxnSpPr>
        <p:spPr>
          <a:xfrm flipV="1">
            <a:off x="4000680" y="1999440"/>
            <a:ext cx="1000800" cy="3072600"/>
          </a:xfrm>
          <a:prstGeom prst="straightConnector1">
            <a:avLst/>
          </a:prstGeom>
          <a:ln w="19080">
            <a:solidFill>
              <a:srgbClr val="ff0000"/>
            </a:solidFill>
            <a:miter/>
            <a:tailEnd len="lg" type="triangle" w="lg"/>
          </a:ln>
        </p:spPr>
      </p:cxnSp>
      <p:sp>
        <p:nvSpPr>
          <p:cNvPr id="53" name=""/>
          <p:cNvSpPr/>
          <p:nvPr/>
        </p:nvSpPr>
        <p:spPr>
          <a:xfrm>
            <a:off x="6944040" y="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8T07:37:18Z</dcterms:created>
  <dc:creator>nagae</dc:creator>
  <dc:description/>
  <dc:language>en-US</dc:language>
  <cp:lastModifiedBy>Kats</cp:lastModifiedBy>
  <dcterms:modified xsi:type="dcterms:W3CDTF">2009-04-12T05:52:45Z</dcterms:modified>
  <cp:revision>10</cp:revision>
  <dc:subject/>
  <dc:title>スライド 1</dc:title>
</cp:coreProperties>
</file>